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0" d="100"/>
          <a:sy n="90" d="100"/>
        </p:scale>
        <p:origin x="1162" y="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649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4567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537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4368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6074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9399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42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5893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0002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7224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96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74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617B58AB-1146-317A-9194-46E401EE4272}"/>
              </a:ext>
            </a:extLst>
          </p:cNvPr>
          <p:cNvGrpSpPr/>
          <p:nvPr/>
        </p:nvGrpSpPr>
        <p:grpSpPr>
          <a:xfrm>
            <a:off x="718308" y="705282"/>
            <a:ext cx="7999597" cy="5252681"/>
            <a:chOff x="718308" y="705282"/>
            <a:chExt cx="7999597" cy="5252681"/>
          </a:xfrm>
        </p:grpSpPr>
        <p:sp>
          <p:nvSpPr>
            <p:cNvPr id="2" name="テキスト ボックス 1"/>
            <p:cNvSpPr txBox="1"/>
            <p:nvPr/>
          </p:nvSpPr>
          <p:spPr>
            <a:xfrm>
              <a:off x="6771210" y="3122238"/>
              <a:ext cx="194669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32 </a:t>
              </a:r>
              <a:r>
                <a:rPr lang="en-US" altLang="ja-JP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PAR-2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直線矢印コネクタ 9"/>
            <p:cNvCxnSpPr/>
            <p:nvPr/>
          </p:nvCxnSpPr>
          <p:spPr>
            <a:xfrm flipH="1">
              <a:off x="6313162" y="3299220"/>
              <a:ext cx="478867" cy="0"/>
            </a:xfrm>
            <a:prstGeom prst="straightConnector1">
              <a:avLst/>
            </a:prstGeom>
            <a:ln w="28575" cmpd="sng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/>
            <p:cNvCxnSpPr/>
            <p:nvPr/>
          </p:nvCxnSpPr>
          <p:spPr>
            <a:xfrm>
              <a:off x="2779762" y="2826443"/>
              <a:ext cx="0" cy="472777"/>
            </a:xfrm>
            <a:prstGeom prst="line">
              <a:avLst/>
            </a:prstGeom>
            <a:ln w="12700" cmpd="sng"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3" name="図 2" descr="200515_PAR2-3.ti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3550" y="705282"/>
              <a:ext cx="5346278" cy="3994346"/>
            </a:xfrm>
            <a:prstGeom prst="rect">
              <a:avLst/>
            </a:prstGeom>
          </p:spPr>
        </p:pic>
        <p:grpSp>
          <p:nvGrpSpPr>
            <p:cNvPr id="14" name="図形グループ 13"/>
            <p:cNvGrpSpPr/>
            <p:nvPr/>
          </p:nvGrpSpPr>
          <p:grpSpPr>
            <a:xfrm>
              <a:off x="2758052" y="2793875"/>
              <a:ext cx="875937" cy="550440"/>
              <a:chOff x="3485768" y="643134"/>
              <a:chExt cx="875937" cy="550440"/>
            </a:xfrm>
          </p:grpSpPr>
          <p:cxnSp>
            <p:nvCxnSpPr>
              <p:cNvPr id="9" name="直線コネクタ 8"/>
              <p:cNvCxnSpPr/>
              <p:nvPr/>
            </p:nvCxnSpPr>
            <p:spPr>
              <a:xfrm>
                <a:off x="3496194" y="653574"/>
                <a:ext cx="0" cy="54000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線コネクタ 10"/>
              <p:cNvCxnSpPr/>
              <p:nvPr/>
            </p:nvCxnSpPr>
            <p:spPr>
              <a:xfrm>
                <a:off x="4354169" y="643134"/>
                <a:ext cx="0" cy="54000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直線コネクタ 7"/>
              <p:cNvCxnSpPr/>
              <p:nvPr/>
            </p:nvCxnSpPr>
            <p:spPr>
              <a:xfrm flipV="1">
                <a:off x="3496193" y="651339"/>
                <a:ext cx="865512" cy="10856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2"/>
              <p:cNvCxnSpPr/>
              <p:nvPr/>
            </p:nvCxnSpPr>
            <p:spPr>
              <a:xfrm flipV="1">
                <a:off x="3485768" y="1172843"/>
                <a:ext cx="865512" cy="10856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" name="テキスト ボックス 3"/>
            <p:cNvSpPr txBox="1"/>
            <p:nvPr/>
          </p:nvSpPr>
          <p:spPr>
            <a:xfrm rot="19301469">
              <a:off x="1180117" y="5080073"/>
              <a:ext cx="14561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UVEC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 rot="19301469">
              <a:off x="1101806" y="5241979"/>
              <a:ext cx="204868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en-US" altLang="ja-JP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 rot="19301469">
              <a:off x="718308" y="5517425"/>
              <a:ext cx="29976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1 (5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 rot="19301469">
              <a:off x="927912" y="5592702"/>
              <a:ext cx="3239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1 (10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 rot="19301469">
              <a:off x="1314450" y="5606097"/>
              <a:ext cx="33004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1 (20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 rot="19301469">
              <a:off x="1998978" y="5528482"/>
              <a:ext cx="29976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2 (5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 rot="19301469">
              <a:off x="2180238" y="5619409"/>
              <a:ext cx="3239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2 (10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 rot="19301469">
              <a:off x="2547354" y="5611639"/>
              <a:ext cx="33004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2 (20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object 2">
            <a:extLst>
              <a:ext uri="{FF2B5EF4-FFF2-40B4-BE49-F238E27FC236}">
                <a16:creationId xmlns:a16="http://schemas.microsoft.com/office/drawing/2014/main" id="{F1B5D985-4FE5-4AEF-B3CC-C7ECC54AF8D7}"/>
              </a:ext>
            </a:extLst>
          </p:cNvPr>
          <p:cNvSpPr txBox="1"/>
          <p:nvPr/>
        </p:nvSpPr>
        <p:spPr>
          <a:xfrm>
            <a:off x="100018" y="37968"/>
            <a:ext cx="1445883" cy="3821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400" spc="-25" dirty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sz="2400" spc="-2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2400" spc="-20" dirty="0">
                <a:latin typeface="Arial" panose="020B0604020202020204" pitchFamily="34" charset="0"/>
                <a:cs typeface="Arial" panose="020B0604020202020204" pitchFamily="34" charset="0"/>
              </a:rPr>
              <a:t>ure S3</a:t>
            </a:r>
            <a:r>
              <a:rPr sz="2400" spc="-3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304179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39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ホワイト</vt:lpstr>
      <vt:lpstr>PowerPoint プレゼンテーション</vt:lpstr>
    </vt:vector>
  </TitlesOfParts>
  <Company>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 a</dc:creator>
  <cp:lastModifiedBy>佐久間　理吏</cp:lastModifiedBy>
  <cp:revision>18</cp:revision>
  <dcterms:created xsi:type="dcterms:W3CDTF">2022-08-22T02:01:34Z</dcterms:created>
  <dcterms:modified xsi:type="dcterms:W3CDTF">2023-03-15T03:37:01Z</dcterms:modified>
</cp:coreProperties>
</file>